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85" autoAdjust="0"/>
    <p:restoredTop sz="94660"/>
  </p:normalViewPr>
  <p:slideViewPr>
    <p:cSldViewPr snapToGrid="0">
      <p:cViewPr varScale="1">
        <p:scale>
          <a:sx n="81" d="100"/>
          <a:sy n="81" d="100"/>
        </p:scale>
        <p:origin x="61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52D265-64A0-7BCA-38A5-469C4D4084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2971239-A1FA-F3EA-08CA-2FA14E2E74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94EF0BB-96DD-6136-183D-44F91BB09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64BF3-379E-4C86-BE2B-51E7AF0C48AA}" type="datetimeFigureOut">
              <a:rPr lang="zh-CN" altLang="en-US" smtClean="0"/>
              <a:t>2024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9DCA36-2B36-5324-FA3B-CB0779D668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9610CFC-FCBB-7356-11AC-1BA9D08117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AF59F-A9A1-459F-B7A1-2CD9506A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8954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374D18-D99E-44FA-0488-C52623C744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744391E-E9E6-BE88-03F9-41AB682EE0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33AA46-6B90-EE31-9F12-096A27F7E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64BF3-379E-4C86-BE2B-51E7AF0C48AA}" type="datetimeFigureOut">
              <a:rPr lang="zh-CN" altLang="en-US" smtClean="0"/>
              <a:t>2024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A8DF918-77C3-82F5-66C1-C30E91203E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3DD4BD2-56E6-C727-9295-F9BBC97D90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AF59F-A9A1-459F-B7A1-2CD9506A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6224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EE1A337-0525-0ECE-5AC4-2F36C36719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AA5679C-F8A9-36BE-6754-F6D252526D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8BFD75-EE18-D77F-02AF-4D2027CCF7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64BF3-379E-4C86-BE2B-51E7AF0C48AA}" type="datetimeFigureOut">
              <a:rPr lang="zh-CN" altLang="en-US" smtClean="0"/>
              <a:t>2024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3253AD-B8CB-B7AF-DDBC-2CA83B04B8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8850FD-EC63-E773-8105-096F19299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AF59F-A9A1-459F-B7A1-2CD9506A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58594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FFD57A-78A1-FF96-5AA6-DA6B8AB63D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5115418-F751-55F4-6BDC-3678BC4FD9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9CB866-395C-1F08-0596-94EB0973D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64BF3-379E-4C86-BE2B-51E7AF0C48AA}" type="datetimeFigureOut">
              <a:rPr lang="zh-CN" altLang="en-US" smtClean="0"/>
              <a:t>2024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7A459CB-C5FE-3E04-1CA5-0620CBA05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73BB8E6-A2A9-335B-9E92-D87777669D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AF59F-A9A1-459F-B7A1-2CD9506A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0342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EF13FD-70EE-50BC-B2AA-DEDCA514F6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653E3AD-C92E-5F70-DF52-D04049118A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F8038E-5FA9-0269-63EA-5D2676D876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64BF3-379E-4C86-BE2B-51E7AF0C48AA}" type="datetimeFigureOut">
              <a:rPr lang="zh-CN" altLang="en-US" smtClean="0"/>
              <a:t>2024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7044D1-F327-7D1C-835F-FF101A6376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E51151-8165-402D-5071-413B2F48FE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AF59F-A9A1-459F-B7A1-2CD9506A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0015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C6BF44-9A62-60B3-1277-27D8374E60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108FC92-CFD6-4087-FDB3-4E816FA2F5A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5EB06B-E0A6-3BB1-68DB-3CD3857D24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EED604A-15CC-6AB4-C866-6C0BE93913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64BF3-379E-4C86-BE2B-51E7AF0C48AA}" type="datetimeFigureOut">
              <a:rPr lang="zh-CN" altLang="en-US" smtClean="0"/>
              <a:t>2024/5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F9A4CCC-D724-7915-EEB7-F644A70CA9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757BC2D-E80E-B601-163F-8A72F531D6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AF59F-A9A1-459F-B7A1-2CD9506A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4888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140D502-46E9-73F2-B077-641AE616D3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BC66427-EAE6-64A6-F21A-CDCE023FDC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8A6380F-FEA0-9876-B234-2E2884736A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1B45A29-E0F7-11B5-1C8F-6132CBF40DC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9FD5065-4AC8-364C-9CBF-353BED24B2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3FA36E2-D28A-58D1-8C9C-D044DF6D93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64BF3-379E-4C86-BE2B-51E7AF0C48AA}" type="datetimeFigureOut">
              <a:rPr lang="zh-CN" altLang="en-US" smtClean="0"/>
              <a:t>2024/5/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AF14B20-2A0E-4EB4-78D1-77A2F119D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DB2FB8C-15FF-3496-2D09-4A8942E5BD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AF59F-A9A1-459F-B7A1-2CD9506A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04624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9798490-B513-A54C-379A-BECB153EB7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83CD653-2EC2-EB8F-BE6A-6295612F03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64BF3-379E-4C86-BE2B-51E7AF0C48AA}" type="datetimeFigureOut">
              <a:rPr lang="zh-CN" altLang="en-US" smtClean="0"/>
              <a:t>2024/5/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729457E-A2AE-9148-48A5-F700F24FA3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3843F8A-2728-8C21-9C1A-6C0E024B95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AF59F-A9A1-459F-B7A1-2CD9506A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4739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6B106D1-39D1-0C14-4557-601FD704E7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64BF3-379E-4C86-BE2B-51E7AF0C48AA}" type="datetimeFigureOut">
              <a:rPr lang="zh-CN" altLang="en-US" smtClean="0"/>
              <a:t>2024/5/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8B85494-945D-7727-C682-5E3E4D3FC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2CE63C8-CCFB-4F73-F3C2-596458A6E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AF59F-A9A1-459F-B7A1-2CD9506A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1494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B745DC-92BB-892F-90CA-DEA81E5B14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A752F38-605A-0356-DBA8-0ED779CDF5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555695D-6050-CA74-84E2-E8EBC98D4A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F63C172-2849-02DC-073B-900B250B1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64BF3-379E-4C86-BE2B-51E7AF0C48AA}" type="datetimeFigureOut">
              <a:rPr lang="zh-CN" altLang="en-US" smtClean="0"/>
              <a:t>2024/5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D633192-49B6-BFCC-0770-8C440FC400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709E456-9569-5874-1D88-6EB5E102D0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AF59F-A9A1-459F-B7A1-2CD9506A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706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807E13-EE06-B1B9-A3B6-80DFAE53AC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615BDEA-C27E-35C9-9FBB-F5902B6A82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798EDBD-0B53-48EA-B6A4-008BA783E8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9E0465-BC10-C027-2C76-54DE801084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64BF3-379E-4C86-BE2B-51E7AF0C48AA}" type="datetimeFigureOut">
              <a:rPr lang="zh-CN" altLang="en-US" smtClean="0"/>
              <a:t>2024/5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17043C0-EC62-193E-A377-47BB73CF92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6201772-A7AD-6A76-11D0-8FF065E0D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AF59F-A9A1-459F-B7A1-2CD9506A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0629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5AD855C-52C4-A1A8-95C4-D10DEDBB1D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9CC56FA-5E18-00DF-8776-B33D39BED1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ADC9C7F-0507-C4B7-7150-03F524E189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664BF3-379E-4C86-BE2B-51E7AF0C48AA}" type="datetimeFigureOut">
              <a:rPr lang="zh-CN" altLang="en-US" smtClean="0"/>
              <a:t>2024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2D8F52-CBCB-0798-B151-48E3FAF11F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29ECC4-BB13-A23E-897B-A92FB386C4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0AF59F-A9A1-459F-B7A1-2CD9506A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1161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microsoft.com/office/2007/relationships/hdphoto" Target="../media/hdphoto6.wdp"/><Relationship Id="rId3" Type="http://schemas.openxmlformats.org/officeDocument/2006/relationships/image" Target="../media/image5.png"/><Relationship Id="rId7" Type="http://schemas.microsoft.com/office/2007/relationships/hdphoto" Target="../media/hdphoto3.wdp"/><Relationship Id="rId12" Type="http://schemas.openxmlformats.org/officeDocument/2006/relationships/image" Target="../media/image10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microsoft.com/office/2007/relationships/hdphoto" Target="../media/hdphoto5.wdp"/><Relationship Id="rId5" Type="http://schemas.openxmlformats.org/officeDocument/2006/relationships/image" Target="../media/image6.png"/><Relationship Id="rId10" Type="http://schemas.openxmlformats.org/officeDocument/2006/relationships/image" Target="../media/image9.png"/><Relationship Id="rId4" Type="http://schemas.microsoft.com/office/2007/relationships/hdphoto" Target="../media/hdphoto2.wdp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文本框 30">
            <a:extLst>
              <a:ext uri="{FF2B5EF4-FFF2-40B4-BE49-F238E27FC236}">
                <a16:creationId xmlns:a16="http://schemas.microsoft.com/office/drawing/2014/main" id="{04503BAF-4195-23AD-5312-B5F70133C07F}"/>
              </a:ext>
            </a:extLst>
          </p:cNvPr>
          <p:cNvSpPr txBox="1"/>
          <p:nvPr/>
        </p:nvSpPr>
        <p:spPr>
          <a:xfrm>
            <a:off x="117077" y="157273"/>
            <a:ext cx="46027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Western Blotting-Figure 2A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85F1F1FF-8F66-DE18-3BE2-2462B814D06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5059" r="4227"/>
          <a:stretch/>
        </p:blipFill>
        <p:spPr>
          <a:xfrm>
            <a:off x="2660131" y="1471822"/>
            <a:ext cx="2768664" cy="1831262"/>
          </a:xfrm>
          <a:prstGeom prst="rect">
            <a:avLst/>
          </a:prstGeom>
        </p:spPr>
      </p:pic>
      <p:sp>
        <p:nvSpPr>
          <p:cNvPr id="33" name="文本框 32">
            <a:extLst>
              <a:ext uri="{FF2B5EF4-FFF2-40B4-BE49-F238E27FC236}">
                <a16:creationId xmlns:a16="http://schemas.microsoft.com/office/drawing/2014/main" id="{D301ED89-49FF-A1F1-D173-CAD3C67CC60C}"/>
              </a:ext>
            </a:extLst>
          </p:cNvPr>
          <p:cNvSpPr txBox="1"/>
          <p:nvPr/>
        </p:nvSpPr>
        <p:spPr>
          <a:xfrm>
            <a:off x="2418449" y="230557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B0AEB30-C322-4648-EA7B-8EC2A45D5220}"/>
              </a:ext>
            </a:extLst>
          </p:cNvPr>
          <p:cNvSpPr txBox="1"/>
          <p:nvPr/>
        </p:nvSpPr>
        <p:spPr>
          <a:xfrm>
            <a:off x="2399875" y="204987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1AD1E3DE-CAD5-895B-F3B8-89774CD37960}"/>
              </a:ext>
            </a:extLst>
          </p:cNvPr>
          <p:cNvSpPr txBox="1"/>
          <p:nvPr/>
        </p:nvSpPr>
        <p:spPr>
          <a:xfrm>
            <a:off x="2411364" y="185496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6CC3FE62-38FE-7526-EA49-65CA5F45DCD8}"/>
              </a:ext>
            </a:extLst>
          </p:cNvPr>
          <p:cNvSpPr txBox="1"/>
          <p:nvPr/>
        </p:nvSpPr>
        <p:spPr>
          <a:xfrm>
            <a:off x="2382182" y="1602082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CD0DC967-1CAD-9D3E-8CBF-CC654AF5B2B2}"/>
              </a:ext>
            </a:extLst>
          </p:cNvPr>
          <p:cNvSpPr txBox="1"/>
          <p:nvPr/>
        </p:nvSpPr>
        <p:spPr>
          <a:xfrm>
            <a:off x="2377108" y="1472038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541DE940-4193-4CC8-4A43-12A37ACA2A3A}"/>
              </a:ext>
            </a:extLst>
          </p:cNvPr>
          <p:cNvSpPr txBox="1"/>
          <p:nvPr/>
        </p:nvSpPr>
        <p:spPr>
          <a:xfrm>
            <a:off x="2390880" y="532232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C2BB4F06-D6BE-911C-A618-F4E85F4CF718}"/>
              </a:ext>
            </a:extLst>
          </p:cNvPr>
          <p:cNvSpPr txBox="1"/>
          <p:nvPr/>
        </p:nvSpPr>
        <p:spPr>
          <a:xfrm>
            <a:off x="2390880" y="508190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BD38CDD6-2190-E4FD-D385-F09B81AB9A58}"/>
              </a:ext>
            </a:extLst>
          </p:cNvPr>
          <p:cNvSpPr txBox="1"/>
          <p:nvPr/>
        </p:nvSpPr>
        <p:spPr>
          <a:xfrm>
            <a:off x="2390880" y="485468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AC0A3058-BEE2-628F-4551-ADF628C9015E}"/>
              </a:ext>
            </a:extLst>
          </p:cNvPr>
          <p:cNvSpPr txBox="1"/>
          <p:nvPr/>
        </p:nvSpPr>
        <p:spPr>
          <a:xfrm>
            <a:off x="2390880" y="568382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9" name="图片 58">
            <a:extLst>
              <a:ext uri="{FF2B5EF4-FFF2-40B4-BE49-F238E27FC236}">
                <a16:creationId xmlns:a16="http://schemas.microsoft.com/office/drawing/2014/main" id="{50ACF9EA-D9C1-A2C6-7AAE-F1F531F9183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14" t="2476" r="1510" b="4771"/>
          <a:stretch/>
        </p:blipFill>
        <p:spPr>
          <a:xfrm>
            <a:off x="2655320" y="4460374"/>
            <a:ext cx="2768664" cy="1786919"/>
          </a:xfrm>
          <a:prstGeom prst="rect">
            <a:avLst/>
          </a:prstGeom>
        </p:spPr>
      </p:pic>
      <p:sp>
        <p:nvSpPr>
          <p:cNvPr id="60" name="文本框 59">
            <a:extLst>
              <a:ext uri="{FF2B5EF4-FFF2-40B4-BE49-F238E27FC236}">
                <a16:creationId xmlns:a16="http://schemas.microsoft.com/office/drawing/2014/main" id="{59E88DF3-0C4B-4C91-9D46-BB4D611C65D6}"/>
              </a:ext>
            </a:extLst>
          </p:cNvPr>
          <p:cNvSpPr txBox="1"/>
          <p:nvPr/>
        </p:nvSpPr>
        <p:spPr>
          <a:xfrm>
            <a:off x="5385817" y="5628231"/>
            <a:ext cx="10054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36KD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A90D6DB2-530A-EED2-DCFD-E533C4327383}"/>
              </a:ext>
            </a:extLst>
          </p:cNvPr>
          <p:cNvSpPr txBox="1"/>
          <p:nvPr/>
        </p:nvSpPr>
        <p:spPr>
          <a:xfrm rot="19040784">
            <a:off x="3705661" y="1116958"/>
            <a:ext cx="7681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ALL4-Trm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A5A9F068-52F4-B9B7-1F00-D4805CA2F49F}"/>
              </a:ext>
            </a:extLst>
          </p:cNvPr>
          <p:cNvSpPr txBox="1"/>
          <p:nvPr/>
        </p:nvSpPr>
        <p:spPr>
          <a:xfrm rot="18898773">
            <a:off x="2598517" y="1125432"/>
            <a:ext cx="882916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2A12A34C-C495-92F7-B721-047D7FD2A2BA}"/>
              </a:ext>
            </a:extLst>
          </p:cNvPr>
          <p:cNvSpPr txBox="1"/>
          <p:nvPr/>
        </p:nvSpPr>
        <p:spPr>
          <a:xfrm rot="19062352">
            <a:off x="2999308" y="1282800"/>
            <a:ext cx="52153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A4C37658-541E-B20F-A252-A562BF279B64}"/>
              </a:ext>
            </a:extLst>
          </p:cNvPr>
          <p:cNvSpPr txBox="1"/>
          <p:nvPr/>
        </p:nvSpPr>
        <p:spPr>
          <a:xfrm rot="19012756">
            <a:off x="3239359" y="1125431"/>
            <a:ext cx="104718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ALL4-WT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C39CAA0F-113A-A415-40E7-C6C91B33F95F}"/>
              </a:ext>
            </a:extLst>
          </p:cNvPr>
          <p:cNvSpPr txBox="1"/>
          <p:nvPr/>
        </p:nvSpPr>
        <p:spPr>
          <a:xfrm rot="19040784">
            <a:off x="4797096" y="1203878"/>
            <a:ext cx="7681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ALL4-Trm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FE8C693E-C29C-09A5-433F-CE6516A8ACDD}"/>
              </a:ext>
            </a:extLst>
          </p:cNvPr>
          <p:cNvSpPr txBox="1"/>
          <p:nvPr/>
        </p:nvSpPr>
        <p:spPr>
          <a:xfrm rot="19062352">
            <a:off x="4151562" y="1265297"/>
            <a:ext cx="52153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36A917DA-E1E9-A615-CE41-BD3D6E2F38F4}"/>
              </a:ext>
            </a:extLst>
          </p:cNvPr>
          <p:cNvSpPr txBox="1"/>
          <p:nvPr/>
        </p:nvSpPr>
        <p:spPr>
          <a:xfrm rot="19012756">
            <a:off x="4352084" y="1157762"/>
            <a:ext cx="104718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ALL4-WT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54195E96-7761-BE82-1EB1-D4A155D1F28A}"/>
              </a:ext>
            </a:extLst>
          </p:cNvPr>
          <p:cNvSpPr txBox="1"/>
          <p:nvPr/>
        </p:nvSpPr>
        <p:spPr>
          <a:xfrm rot="19040784">
            <a:off x="3460729" y="4054101"/>
            <a:ext cx="7681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ALL4-Trm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32BD3BA5-2D52-5CC2-3F3B-BDF20B679B6B}"/>
              </a:ext>
            </a:extLst>
          </p:cNvPr>
          <p:cNvSpPr txBox="1"/>
          <p:nvPr/>
        </p:nvSpPr>
        <p:spPr>
          <a:xfrm rot="18898773">
            <a:off x="2478418" y="4023552"/>
            <a:ext cx="882916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BEDDD08C-7363-4F79-7B89-434431171C7E}"/>
              </a:ext>
            </a:extLst>
          </p:cNvPr>
          <p:cNvSpPr txBox="1"/>
          <p:nvPr/>
        </p:nvSpPr>
        <p:spPr>
          <a:xfrm rot="19062352">
            <a:off x="2879209" y="4180920"/>
            <a:ext cx="52153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94DBB621-7EAE-E6D9-B54A-58D245F24A75}"/>
              </a:ext>
            </a:extLst>
          </p:cNvPr>
          <p:cNvSpPr txBox="1"/>
          <p:nvPr/>
        </p:nvSpPr>
        <p:spPr>
          <a:xfrm rot="19012756">
            <a:off x="3125969" y="3967935"/>
            <a:ext cx="104718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ALL4-WT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DA35F47A-23B9-6694-5B8C-6E00E3191DB4}"/>
              </a:ext>
            </a:extLst>
          </p:cNvPr>
          <p:cNvSpPr txBox="1"/>
          <p:nvPr/>
        </p:nvSpPr>
        <p:spPr>
          <a:xfrm rot="19040784">
            <a:off x="4593611" y="4085524"/>
            <a:ext cx="7681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ALL4-Trm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CA5630AE-4EC9-6CD7-467D-F901B7BD733D}"/>
              </a:ext>
            </a:extLst>
          </p:cNvPr>
          <p:cNvSpPr txBox="1"/>
          <p:nvPr/>
        </p:nvSpPr>
        <p:spPr>
          <a:xfrm rot="19062352">
            <a:off x="3918382" y="4143020"/>
            <a:ext cx="52153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8229D06F-78F7-8A79-9865-D0029443530D}"/>
              </a:ext>
            </a:extLst>
          </p:cNvPr>
          <p:cNvSpPr txBox="1"/>
          <p:nvPr/>
        </p:nvSpPr>
        <p:spPr>
          <a:xfrm rot="19012756">
            <a:off x="4198686" y="3992560"/>
            <a:ext cx="104718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ALL4-WT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A7C5BD4A-F750-D936-CFD9-6E4257ECC9B0}"/>
              </a:ext>
            </a:extLst>
          </p:cNvPr>
          <p:cNvSpPr txBox="1"/>
          <p:nvPr/>
        </p:nvSpPr>
        <p:spPr>
          <a:xfrm>
            <a:off x="1801510" y="3843028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trippin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矩形 75">
            <a:extLst>
              <a:ext uri="{FF2B5EF4-FFF2-40B4-BE49-F238E27FC236}">
                <a16:creationId xmlns:a16="http://schemas.microsoft.com/office/drawing/2014/main" id="{7526AF76-410D-7509-5B8A-3B9B18F726D6}"/>
              </a:ext>
            </a:extLst>
          </p:cNvPr>
          <p:cNvSpPr/>
          <p:nvPr/>
        </p:nvSpPr>
        <p:spPr>
          <a:xfrm>
            <a:off x="2887782" y="5553160"/>
            <a:ext cx="818790" cy="25267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7" name="矩形 76">
            <a:extLst>
              <a:ext uri="{FF2B5EF4-FFF2-40B4-BE49-F238E27FC236}">
                <a16:creationId xmlns:a16="http://schemas.microsoft.com/office/drawing/2014/main" id="{27AD5BAF-1394-BE68-671D-0BF8DAF0D357}"/>
              </a:ext>
            </a:extLst>
          </p:cNvPr>
          <p:cNvSpPr/>
          <p:nvPr/>
        </p:nvSpPr>
        <p:spPr>
          <a:xfrm>
            <a:off x="2938965" y="1566472"/>
            <a:ext cx="972017" cy="147471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EBB90EE0-240C-5CDF-5BFC-9779A499266A}"/>
              </a:ext>
            </a:extLst>
          </p:cNvPr>
          <p:cNvSpPr txBox="1"/>
          <p:nvPr/>
        </p:nvSpPr>
        <p:spPr>
          <a:xfrm>
            <a:off x="5180530" y="1518438"/>
            <a:ext cx="12453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nti-Flag</a:t>
            </a:r>
            <a:r>
              <a: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12KD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1" name="图片 90">
            <a:extLst>
              <a:ext uri="{FF2B5EF4-FFF2-40B4-BE49-F238E27FC236}">
                <a16:creationId xmlns:a16="http://schemas.microsoft.com/office/drawing/2014/main" id="{D8AF600E-4A28-FC1E-2EF8-8FF24B483DA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383" t="9265" r="61395" b="16362"/>
          <a:stretch/>
        </p:blipFill>
        <p:spPr>
          <a:xfrm>
            <a:off x="8348348" y="2610316"/>
            <a:ext cx="870595" cy="15308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2" name="图片 91">
            <a:extLst>
              <a:ext uri="{FF2B5EF4-FFF2-40B4-BE49-F238E27FC236}">
                <a16:creationId xmlns:a16="http://schemas.microsoft.com/office/drawing/2014/main" id="{30A3CBA5-CDA7-850A-B6C7-1131EE158D5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68" t="60169" r="60577" b="30070"/>
          <a:stretch/>
        </p:blipFill>
        <p:spPr>
          <a:xfrm>
            <a:off x="8342871" y="4246246"/>
            <a:ext cx="895235" cy="19183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3" name="文本框 92">
            <a:extLst>
              <a:ext uri="{FF2B5EF4-FFF2-40B4-BE49-F238E27FC236}">
                <a16:creationId xmlns:a16="http://schemas.microsoft.com/office/drawing/2014/main" id="{7498F8C5-E82C-EA65-08B3-99760F2D39D3}"/>
              </a:ext>
            </a:extLst>
          </p:cNvPr>
          <p:cNvSpPr txBox="1"/>
          <p:nvPr/>
        </p:nvSpPr>
        <p:spPr>
          <a:xfrm>
            <a:off x="7555273" y="2944786"/>
            <a:ext cx="806631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nti-Flag</a:t>
            </a: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ALL4-WT </a:t>
            </a: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  112KD</a:t>
            </a: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ALL4-Trm</a:t>
            </a: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68CB4749-C275-D05A-03E9-8817E04EFE2D}"/>
              </a:ext>
            </a:extLst>
          </p:cNvPr>
          <p:cNvSpPr txBox="1"/>
          <p:nvPr/>
        </p:nvSpPr>
        <p:spPr>
          <a:xfrm>
            <a:off x="7753443" y="4156306"/>
            <a:ext cx="6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36KD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3B2291AC-975A-0EF6-50B8-3DA38C9F96FD}"/>
              </a:ext>
            </a:extLst>
          </p:cNvPr>
          <p:cNvSpPr txBox="1"/>
          <p:nvPr/>
        </p:nvSpPr>
        <p:spPr>
          <a:xfrm rot="19040784">
            <a:off x="8868119" y="2215011"/>
            <a:ext cx="8066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L4-Trm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133DF544-F65E-65DE-FE91-EC49C1386E06}"/>
              </a:ext>
            </a:extLst>
          </p:cNvPr>
          <p:cNvSpPr txBox="1"/>
          <p:nvPr/>
        </p:nvSpPr>
        <p:spPr>
          <a:xfrm rot="19062352">
            <a:off x="8305835" y="2341830"/>
            <a:ext cx="52153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1100" b="1" dirty="0"/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F7B668E6-45D9-1375-BD40-3A58F4397AAD}"/>
              </a:ext>
            </a:extLst>
          </p:cNvPr>
          <p:cNvSpPr txBox="1"/>
          <p:nvPr/>
        </p:nvSpPr>
        <p:spPr>
          <a:xfrm rot="19012756">
            <a:off x="8552595" y="2128845"/>
            <a:ext cx="104718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L4-WT</a:t>
            </a:r>
            <a:endParaRPr lang="zh-CN" altLang="en-US" sz="900" b="1" dirty="0"/>
          </a:p>
        </p:txBody>
      </p:sp>
    </p:spTree>
    <p:extLst>
      <p:ext uri="{BB962C8B-B14F-4D97-AF65-F5344CB8AC3E}">
        <p14:creationId xmlns:p14="http://schemas.microsoft.com/office/powerpoint/2010/main" val="399791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组合 54">
            <a:extLst>
              <a:ext uri="{FF2B5EF4-FFF2-40B4-BE49-F238E27FC236}">
                <a16:creationId xmlns:a16="http://schemas.microsoft.com/office/drawing/2014/main" id="{5A4EB6F6-CEE1-309B-A691-05BBAF0F9C0F}"/>
              </a:ext>
            </a:extLst>
          </p:cNvPr>
          <p:cNvGrpSpPr/>
          <p:nvPr/>
        </p:nvGrpSpPr>
        <p:grpSpPr>
          <a:xfrm>
            <a:off x="5789058" y="1590309"/>
            <a:ext cx="4218765" cy="2012523"/>
            <a:chOff x="4725108" y="4524871"/>
            <a:chExt cx="3187803" cy="1381775"/>
          </a:xfrm>
        </p:grpSpPr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57D9181D-042B-826E-746D-C0196204F6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14" t="2514" r="2086" b="2299"/>
            <a:stretch/>
          </p:blipFill>
          <p:spPr>
            <a:xfrm>
              <a:off x="4757829" y="4524871"/>
              <a:ext cx="2018252" cy="1381775"/>
            </a:xfrm>
            <a:prstGeom prst="rect">
              <a:avLst/>
            </a:prstGeom>
          </p:spPr>
        </p:pic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CF5FE8B1-D257-3467-75B6-DD3D58111DCF}"/>
                </a:ext>
              </a:extLst>
            </p:cNvPr>
            <p:cNvSpPr txBox="1"/>
            <p:nvPr/>
          </p:nvSpPr>
          <p:spPr>
            <a:xfrm>
              <a:off x="4725108" y="5214287"/>
              <a:ext cx="236439" cy="1584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BC44264E-12A0-385D-C3F9-CB5FD6681C2D}"/>
                </a:ext>
              </a:extLst>
            </p:cNvPr>
            <p:cNvSpPr txBox="1"/>
            <p:nvPr/>
          </p:nvSpPr>
          <p:spPr>
            <a:xfrm>
              <a:off x="4737608" y="4989163"/>
              <a:ext cx="236439" cy="1584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F679E1A3-4407-48F2-3A74-B6DC36B9FCFD}"/>
                </a:ext>
              </a:extLst>
            </p:cNvPr>
            <p:cNvSpPr txBox="1"/>
            <p:nvPr/>
          </p:nvSpPr>
          <p:spPr>
            <a:xfrm>
              <a:off x="4732684" y="5445119"/>
              <a:ext cx="236439" cy="1584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E4EE6556-7AA9-2A2F-48E9-8AD86357B827}"/>
                </a:ext>
              </a:extLst>
            </p:cNvPr>
            <p:cNvSpPr txBox="1"/>
            <p:nvPr/>
          </p:nvSpPr>
          <p:spPr>
            <a:xfrm>
              <a:off x="6717541" y="5468894"/>
              <a:ext cx="1195370" cy="158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r>
                <a: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：</a:t>
              </a: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6KD</a:t>
              </a: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4C91F5CC-34C5-67E0-E89B-10CD7BBEDF3A}"/>
                </a:ext>
              </a:extLst>
            </p:cNvPr>
            <p:cNvSpPr txBox="1"/>
            <p:nvPr/>
          </p:nvSpPr>
          <p:spPr>
            <a:xfrm>
              <a:off x="6722732" y="5257173"/>
              <a:ext cx="1157494" cy="158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NT11</a:t>
              </a:r>
              <a:r>
                <a:rPr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：</a:t>
              </a: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9KD</a:t>
              </a:r>
            </a:p>
          </p:txBody>
        </p: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4E5EB4AD-D75E-A324-B98A-5BECDCF0754B}"/>
                </a:ext>
              </a:extLst>
            </p:cNvPr>
            <p:cNvSpPr/>
            <p:nvPr/>
          </p:nvSpPr>
          <p:spPr>
            <a:xfrm>
              <a:off x="5828185" y="5271593"/>
              <a:ext cx="618698" cy="115416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EDCFB4D3-D2D5-44DD-47C1-62548B91D122}"/>
                </a:ext>
              </a:extLst>
            </p:cNvPr>
            <p:cNvSpPr/>
            <p:nvPr/>
          </p:nvSpPr>
          <p:spPr>
            <a:xfrm>
              <a:off x="5836829" y="5477805"/>
              <a:ext cx="618698" cy="17348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44" name="文本框 43">
            <a:extLst>
              <a:ext uri="{FF2B5EF4-FFF2-40B4-BE49-F238E27FC236}">
                <a16:creationId xmlns:a16="http://schemas.microsoft.com/office/drawing/2014/main" id="{667E10B9-E8DA-01E4-8E1A-79483DBAF7DD}"/>
              </a:ext>
            </a:extLst>
          </p:cNvPr>
          <p:cNvSpPr txBox="1"/>
          <p:nvPr/>
        </p:nvSpPr>
        <p:spPr>
          <a:xfrm>
            <a:off x="969380" y="2451140"/>
            <a:ext cx="8963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PAX2</a:t>
            </a:r>
            <a:r>
              <a: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45KD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EDFC5298-2573-6AEB-636D-CF10AAA92ABE}"/>
              </a:ext>
            </a:extLst>
          </p:cNvPr>
          <p:cNvSpPr txBox="1"/>
          <p:nvPr/>
        </p:nvSpPr>
        <p:spPr>
          <a:xfrm rot="19040784">
            <a:off x="2775070" y="1147147"/>
            <a:ext cx="958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LL4-Trm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图片 45">
            <a:extLst>
              <a:ext uri="{FF2B5EF4-FFF2-40B4-BE49-F238E27FC236}">
                <a16:creationId xmlns:a16="http://schemas.microsoft.com/office/drawing/2014/main" id="{94CC5DD8-F92E-F8CD-7EA4-537C4DE4D73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4669" r="4601" b="-147"/>
          <a:stretch/>
        </p:blipFill>
        <p:spPr>
          <a:xfrm>
            <a:off x="1774845" y="4542576"/>
            <a:ext cx="3065446" cy="1987589"/>
          </a:xfrm>
          <a:prstGeom prst="rect">
            <a:avLst/>
          </a:prstGeom>
        </p:spPr>
      </p:pic>
      <p:sp>
        <p:nvSpPr>
          <p:cNvPr id="47" name="文本框 46">
            <a:extLst>
              <a:ext uri="{FF2B5EF4-FFF2-40B4-BE49-F238E27FC236}">
                <a16:creationId xmlns:a16="http://schemas.microsoft.com/office/drawing/2014/main" id="{58B46CC1-911E-BB0C-276C-BBD2A0793F40}"/>
              </a:ext>
            </a:extLst>
          </p:cNvPr>
          <p:cNvSpPr txBox="1"/>
          <p:nvPr/>
        </p:nvSpPr>
        <p:spPr>
          <a:xfrm>
            <a:off x="1719832" y="5182988"/>
            <a:ext cx="366856" cy="233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89585C02-891A-0894-BA2E-F2535486D24B}"/>
              </a:ext>
            </a:extLst>
          </p:cNvPr>
          <p:cNvSpPr txBox="1"/>
          <p:nvPr/>
        </p:nvSpPr>
        <p:spPr>
          <a:xfrm>
            <a:off x="1717309" y="547452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3B63F36E-8F37-9A54-1BDA-1E1775666955}"/>
              </a:ext>
            </a:extLst>
          </p:cNvPr>
          <p:cNvSpPr txBox="1"/>
          <p:nvPr/>
        </p:nvSpPr>
        <p:spPr>
          <a:xfrm>
            <a:off x="1702444" y="579142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C3A9C61B-7C67-C0E8-901E-0CBC5761459A}"/>
              </a:ext>
            </a:extLst>
          </p:cNvPr>
          <p:cNvSpPr txBox="1"/>
          <p:nvPr/>
        </p:nvSpPr>
        <p:spPr>
          <a:xfrm>
            <a:off x="942463" y="4338304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trippin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BB979BDC-0980-D0F5-A9B4-65B6FF50ACAD}"/>
              </a:ext>
            </a:extLst>
          </p:cNvPr>
          <p:cNvSpPr txBox="1"/>
          <p:nvPr/>
        </p:nvSpPr>
        <p:spPr>
          <a:xfrm>
            <a:off x="765406" y="5672150"/>
            <a:ext cx="10054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36KD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2" name="图片 51">
            <a:extLst>
              <a:ext uri="{FF2B5EF4-FFF2-40B4-BE49-F238E27FC236}">
                <a16:creationId xmlns:a16="http://schemas.microsoft.com/office/drawing/2014/main" id="{87DE516E-1888-0446-CB26-BB1CA123AC0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4658" y="1598894"/>
            <a:ext cx="3098465" cy="2012508"/>
          </a:xfrm>
          <a:prstGeom prst="rect">
            <a:avLst/>
          </a:prstGeom>
        </p:spPr>
      </p:pic>
      <p:sp>
        <p:nvSpPr>
          <p:cNvPr id="53" name="矩形 52">
            <a:extLst>
              <a:ext uri="{FF2B5EF4-FFF2-40B4-BE49-F238E27FC236}">
                <a16:creationId xmlns:a16="http://schemas.microsoft.com/office/drawing/2014/main" id="{E52CFB0E-981F-551C-CB6F-E841A3784D27}"/>
              </a:ext>
            </a:extLst>
          </p:cNvPr>
          <p:cNvSpPr/>
          <p:nvPr/>
        </p:nvSpPr>
        <p:spPr>
          <a:xfrm>
            <a:off x="2163807" y="2400640"/>
            <a:ext cx="945072" cy="276999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26B95C6B-DB05-5C18-4728-5BFD059FE318}"/>
              </a:ext>
            </a:extLst>
          </p:cNvPr>
          <p:cNvSpPr/>
          <p:nvPr/>
        </p:nvSpPr>
        <p:spPr>
          <a:xfrm>
            <a:off x="2122994" y="5745256"/>
            <a:ext cx="945072" cy="276999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D48849D1-1808-4E84-D587-10FB66B6C074}"/>
              </a:ext>
            </a:extLst>
          </p:cNvPr>
          <p:cNvSpPr txBox="1"/>
          <p:nvPr/>
        </p:nvSpPr>
        <p:spPr>
          <a:xfrm>
            <a:off x="1714711" y="254877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FBF0B966-989E-558E-FEAF-31F25CD1DC6C}"/>
              </a:ext>
            </a:extLst>
          </p:cNvPr>
          <p:cNvSpPr txBox="1"/>
          <p:nvPr/>
        </p:nvSpPr>
        <p:spPr>
          <a:xfrm>
            <a:off x="1722444" y="2210384"/>
            <a:ext cx="366856" cy="233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AB12A4C6-9527-5726-F544-33A48ED29A10}"/>
              </a:ext>
            </a:extLst>
          </p:cNvPr>
          <p:cNvSpPr txBox="1"/>
          <p:nvPr/>
        </p:nvSpPr>
        <p:spPr>
          <a:xfrm rot="18898773">
            <a:off x="1763016" y="1155621"/>
            <a:ext cx="88291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A46A0298-BB69-A3D4-1CDD-40CF8073FC6F}"/>
              </a:ext>
            </a:extLst>
          </p:cNvPr>
          <p:cNvSpPr txBox="1"/>
          <p:nvPr/>
        </p:nvSpPr>
        <p:spPr>
          <a:xfrm rot="19062352">
            <a:off x="2163807" y="1282211"/>
            <a:ext cx="52153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ED0F355-969E-A4B6-C33E-DD4C73B0B4D1}"/>
              </a:ext>
            </a:extLst>
          </p:cNvPr>
          <p:cNvSpPr txBox="1"/>
          <p:nvPr/>
        </p:nvSpPr>
        <p:spPr>
          <a:xfrm rot="19012756">
            <a:off x="2410567" y="1100004"/>
            <a:ext cx="10471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LL4-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54FC181-1206-7AAE-3B26-A65551BE97D3}"/>
              </a:ext>
            </a:extLst>
          </p:cNvPr>
          <p:cNvSpPr txBox="1"/>
          <p:nvPr/>
        </p:nvSpPr>
        <p:spPr>
          <a:xfrm rot="19040784">
            <a:off x="3946941" y="1132462"/>
            <a:ext cx="958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LL4-Trm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C9011489-3627-B788-A2D4-46F784F7EBCD}"/>
              </a:ext>
            </a:extLst>
          </p:cNvPr>
          <p:cNvSpPr txBox="1"/>
          <p:nvPr/>
        </p:nvSpPr>
        <p:spPr>
          <a:xfrm rot="19062352">
            <a:off x="3335678" y="1267526"/>
            <a:ext cx="52153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3B9A49D-F9F6-041F-CDBC-9E02E756FFE8}"/>
              </a:ext>
            </a:extLst>
          </p:cNvPr>
          <p:cNvSpPr txBox="1"/>
          <p:nvPr/>
        </p:nvSpPr>
        <p:spPr>
          <a:xfrm rot="19012756">
            <a:off x="3582438" y="1085319"/>
            <a:ext cx="10471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LL4-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70B6555-C308-3895-F601-A5F6EB0A0DA3}"/>
              </a:ext>
            </a:extLst>
          </p:cNvPr>
          <p:cNvSpPr txBox="1"/>
          <p:nvPr/>
        </p:nvSpPr>
        <p:spPr>
          <a:xfrm rot="19040784">
            <a:off x="6712904" y="1039349"/>
            <a:ext cx="11777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LL4-Trm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F66D24E-AFE0-19B9-2DFD-C2BE2918C437}"/>
              </a:ext>
            </a:extLst>
          </p:cNvPr>
          <p:cNvSpPr txBox="1"/>
          <p:nvPr/>
        </p:nvSpPr>
        <p:spPr>
          <a:xfrm rot="18898773">
            <a:off x="5891072" y="1161230"/>
            <a:ext cx="88291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974844B-5019-6305-C6F1-88EED5467CB3}"/>
              </a:ext>
            </a:extLst>
          </p:cNvPr>
          <p:cNvSpPr txBox="1"/>
          <p:nvPr/>
        </p:nvSpPr>
        <p:spPr>
          <a:xfrm rot="19062352">
            <a:off x="6199521" y="1212030"/>
            <a:ext cx="5176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9C6601C-5E67-D6F8-330F-17CFF51EABE8}"/>
              </a:ext>
            </a:extLst>
          </p:cNvPr>
          <p:cNvSpPr txBox="1"/>
          <p:nvPr/>
        </p:nvSpPr>
        <p:spPr>
          <a:xfrm rot="19012756">
            <a:off x="6403325" y="1096184"/>
            <a:ext cx="10393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LL4-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610E67D-5CBB-B468-A10D-A33CCC446B63}"/>
              </a:ext>
            </a:extLst>
          </p:cNvPr>
          <p:cNvSpPr txBox="1"/>
          <p:nvPr/>
        </p:nvSpPr>
        <p:spPr>
          <a:xfrm rot="19040784">
            <a:off x="7805292" y="1148526"/>
            <a:ext cx="958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LL4-Trm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263390CC-A7B7-C0E7-DC92-7D0702C0E486}"/>
              </a:ext>
            </a:extLst>
          </p:cNvPr>
          <p:cNvSpPr txBox="1"/>
          <p:nvPr/>
        </p:nvSpPr>
        <p:spPr>
          <a:xfrm rot="19062352">
            <a:off x="7257584" y="1202125"/>
            <a:ext cx="52153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9AFC5B7-875D-8B24-1629-D609339C8DCE}"/>
              </a:ext>
            </a:extLst>
          </p:cNvPr>
          <p:cNvSpPr txBox="1"/>
          <p:nvPr/>
        </p:nvSpPr>
        <p:spPr>
          <a:xfrm rot="19012756">
            <a:off x="7440789" y="1101383"/>
            <a:ext cx="10471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LL4-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EB6704C-D047-76B3-05B4-C954E8BEBF6F}"/>
              </a:ext>
            </a:extLst>
          </p:cNvPr>
          <p:cNvSpPr txBox="1"/>
          <p:nvPr/>
        </p:nvSpPr>
        <p:spPr>
          <a:xfrm rot="19040784">
            <a:off x="2819344" y="4087246"/>
            <a:ext cx="958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LL4-Trm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F72E104-414D-39C3-2068-841C0FB73D9B}"/>
              </a:ext>
            </a:extLst>
          </p:cNvPr>
          <p:cNvSpPr txBox="1"/>
          <p:nvPr/>
        </p:nvSpPr>
        <p:spPr>
          <a:xfrm rot="18898773">
            <a:off x="1807290" y="4095720"/>
            <a:ext cx="88291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B01BA2C-7DCB-996B-1031-3081C499D1DF}"/>
              </a:ext>
            </a:extLst>
          </p:cNvPr>
          <p:cNvSpPr txBox="1"/>
          <p:nvPr/>
        </p:nvSpPr>
        <p:spPr>
          <a:xfrm rot="19062352">
            <a:off x="2208081" y="4222310"/>
            <a:ext cx="52153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5AC64921-D99C-6482-68DB-2CF33868F423}"/>
              </a:ext>
            </a:extLst>
          </p:cNvPr>
          <p:cNvSpPr txBox="1"/>
          <p:nvPr/>
        </p:nvSpPr>
        <p:spPr>
          <a:xfrm rot="19012756">
            <a:off x="2454841" y="4040103"/>
            <a:ext cx="10471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LL4-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9644BB6-E77D-FDCF-359E-48B90F21359F}"/>
              </a:ext>
            </a:extLst>
          </p:cNvPr>
          <p:cNvSpPr txBox="1"/>
          <p:nvPr/>
        </p:nvSpPr>
        <p:spPr>
          <a:xfrm rot="19040784">
            <a:off x="3991215" y="4072561"/>
            <a:ext cx="958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LL4-Trm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BAD90C99-9517-F5EE-9468-A33B52871CC3}"/>
              </a:ext>
            </a:extLst>
          </p:cNvPr>
          <p:cNvSpPr txBox="1"/>
          <p:nvPr/>
        </p:nvSpPr>
        <p:spPr>
          <a:xfrm rot="19062352">
            <a:off x="3379952" y="4207625"/>
            <a:ext cx="52153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E1894490-09ED-97D1-08EB-51C15256CF26}"/>
              </a:ext>
            </a:extLst>
          </p:cNvPr>
          <p:cNvSpPr txBox="1"/>
          <p:nvPr/>
        </p:nvSpPr>
        <p:spPr>
          <a:xfrm rot="19012756">
            <a:off x="3626712" y="4025418"/>
            <a:ext cx="10471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LL4-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7E9EDCB-17B7-1F29-16C9-1557BE0D8F1A}"/>
              </a:ext>
            </a:extLst>
          </p:cNvPr>
          <p:cNvSpPr txBox="1"/>
          <p:nvPr/>
        </p:nvSpPr>
        <p:spPr>
          <a:xfrm>
            <a:off x="5344844" y="5117333"/>
            <a:ext cx="5757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WNT11</a:t>
            </a: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39KD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0AE3BED9-C5BB-C515-B7FA-837ADF6CA055}"/>
              </a:ext>
            </a:extLst>
          </p:cNvPr>
          <p:cNvSpPr txBox="1"/>
          <p:nvPr/>
        </p:nvSpPr>
        <p:spPr>
          <a:xfrm>
            <a:off x="5345694" y="5523897"/>
            <a:ext cx="6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36KD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6DD650E6-5511-E32C-105C-D98835AEB1A4}"/>
              </a:ext>
            </a:extLst>
          </p:cNvPr>
          <p:cNvSpPr txBox="1"/>
          <p:nvPr/>
        </p:nvSpPr>
        <p:spPr>
          <a:xfrm>
            <a:off x="8739998" y="5122128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PAX2</a:t>
            </a: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45KD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9" name="图片 78">
            <a:extLst>
              <a:ext uri="{FF2B5EF4-FFF2-40B4-BE49-F238E27FC236}">
                <a16:creationId xmlns:a16="http://schemas.microsoft.com/office/drawing/2014/main" id="{46A07961-3975-2858-124A-3ED3B149A18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467" t="53084" r="56380" b="34216"/>
          <a:stretch/>
        </p:blipFill>
        <p:spPr>
          <a:xfrm>
            <a:off x="7362206" y="5512043"/>
            <a:ext cx="1422255" cy="3410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0" name="图片 79">
            <a:extLst>
              <a:ext uri="{FF2B5EF4-FFF2-40B4-BE49-F238E27FC236}">
                <a16:creationId xmlns:a16="http://schemas.microsoft.com/office/drawing/2014/main" id="{06AA1370-05AF-7C70-0732-3A30D58AF1E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056" t="51726" r="61553" b="40981"/>
          <a:stretch/>
        </p:blipFill>
        <p:spPr>
          <a:xfrm>
            <a:off x="5872211" y="5135198"/>
            <a:ext cx="1422255" cy="3142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1" name="图片 80">
            <a:extLst>
              <a:ext uri="{FF2B5EF4-FFF2-40B4-BE49-F238E27FC236}">
                <a16:creationId xmlns:a16="http://schemas.microsoft.com/office/drawing/2014/main" id="{DE21933A-4C06-1691-E8C4-B08D38C830CE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830" t="70266" r="56837" b="16464"/>
          <a:stretch/>
        </p:blipFill>
        <p:spPr>
          <a:xfrm>
            <a:off x="5872211" y="5517586"/>
            <a:ext cx="1422255" cy="3410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3" name="文本框 82">
            <a:extLst>
              <a:ext uri="{FF2B5EF4-FFF2-40B4-BE49-F238E27FC236}">
                <a16:creationId xmlns:a16="http://schemas.microsoft.com/office/drawing/2014/main" id="{5BCC0058-BE09-9F11-BFB5-A174BA5BB92D}"/>
              </a:ext>
            </a:extLst>
          </p:cNvPr>
          <p:cNvSpPr txBox="1"/>
          <p:nvPr/>
        </p:nvSpPr>
        <p:spPr>
          <a:xfrm>
            <a:off x="8719390" y="5511612"/>
            <a:ext cx="6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  36KD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4" name="图片 83">
            <a:extLst>
              <a:ext uri="{FF2B5EF4-FFF2-40B4-BE49-F238E27FC236}">
                <a16:creationId xmlns:a16="http://schemas.microsoft.com/office/drawing/2014/main" id="{0D67873A-B52A-4998-5439-9A8614CDC5A4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091" t="41335" r="13723" b="45247"/>
          <a:stretch/>
        </p:blipFill>
        <p:spPr>
          <a:xfrm>
            <a:off x="7362206" y="5134186"/>
            <a:ext cx="1422255" cy="32041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5" name="文本框 84">
            <a:extLst>
              <a:ext uri="{FF2B5EF4-FFF2-40B4-BE49-F238E27FC236}">
                <a16:creationId xmlns:a16="http://schemas.microsoft.com/office/drawing/2014/main" id="{584FBAF7-BC24-19B4-5D60-8991AE27B65E}"/>
              </a:ext>
            </a:extLst>
          </p:cNvPr>
          <p:cNvSpPr txBox="1"/>
          <p:nvPr/>
        </p:nvSpPr>
        <p:spPr>
          <a:xfrm rot="19040784">
            <a:off x="6800663" y="4741010"/>
            <a:ext cx="8066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L4-Trm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F751B6D7-5936-EDDB-993B-701203B7719E}"/>
              </a:ext>
            </a:extLst>
          </p:cNvPr>
          <p:cNvSpPr txBox="1"/>
          <p:nvPr/>
        </p:nvSpPr>
        <p:spPr>
          <a:xfrm rot="19062352">
            <a:off x="5898454" y="4827228"/>
            <a:ext cx="52153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 </a:t>
            </a:r>
            <a:endParaRPr lang="zh-CN" altLang="en-US" sz="900" b="1" dirty="0"/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759005B6-73C8-4314-A764-617AA0D50DFF}"/>
              </a:ext>
            </a:extLst>
          </p:cNvPr>
          <p:cNvSpPr txBox="1"/>
          <p:nvPr/>
        </p:nvSpPr>
        <p:spPr>
          <a:xfrm rot="19012756">
            <a:off x="6277720" y="4662166"/>
            <a:ext cx="104718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L4-WT</a:t>
            </a:r>
            <a:endParaRPr lang="zh-CN" altLang="en-US" sz="900" b="1" dirty="0"/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AF16E79A-10DD-D59E-A60E-A9BA920E7C39}"/>
              </a:ext>
            </a:extLst>
          </p:cNvPr>
          <p:cNvSpPr txBox="1"/>
          <p:nvPr/>
        </p:nvSpPr>
        <p:spPr>
          <a:xfrm rot="19040784">
            <a:off x="8195938" y="4741010"/>
            <a:ext cx="8066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L4-Trm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5E462028-3BED-E875-3E20-96B91BB74FFC}"/>
              </a:ext>
            </a:extLst>
          </p:cNvPr>
          <p:cNvSpPr txBox="1"/>
          <p:nvPr/>
        </p:nvSpPr>
        <p:spPr>
          <a:xfrm rot="19062352">
            <a:off x="7394771" y="4827205"/>
            <a:ext cx="52153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 </a:t>
            </a:r>
            <a:endParaRPr lang="zh-CN" altLang="en-US" sz="900" b="1" dirty="0"/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B50B3A75-F2D1-B126-76AA-A816AF7A8B6F}"/>
              </a:ext>
            </a:extLst>
          </p:cNvPr>
          <p:cNvSpPr txBox="1"/>
          <p:nvPr/>
        </p:nvSpPr>
        <p:spPr>
          <a:xfrm rot="19012756">
            <a:off x="7718954" y="4649400"/>
            <a:ext cx="104718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L4-WT</a:t>
            </a:r>
            <a:endParaRPr lang="zh-CN" altLang="en-US" sz="9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92F4D655-8C80-627F-00BD-A9E302E145DC}"/>
              </a:ext>
            </a:extLst>
          </p:cNvPr>
          <p:cNvSpPr txBox="1"/>
          <p:nvPr/>
        </p:nvSpPr>
        <p:spPr>
          <a:xfrm>
            <a:off x="117077" y="157273"/>
            <a:ext cx="46027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Western Blotting-Figure 4B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28330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114</Words>
  <Application>Microsoft Office PowerPoint</Application>
  <PresentationFormat>宽屏</PresentationFormat>
  <Paragraphs>8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雅丽 范</dc:creator>
  <cp:lastModifiedBy>琳 李</cp:lastModifiedBy>
  <cp:revision>13</cp:revision>
  <dcterms:created xsi:type="dcterms:W3CDTF">2024-05-05T14:11:56Z</dcterms:created>
  <dcterms:modified xsi:type="dcterms:W3CDTF">2024-05-06T00:33:31Z</dcterms:modified>
</cp:coreProperties>
</file>